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34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60C00-181A-4E02-B37F-71D53247E1B8}" type="datetimeFigureOut">
              <a:rPr lang="en-IN" smtClean="0"/>
              <a:t>06-09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A3E39-79FB-4318-AC2A-9168D8299D23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42"/>
          <p:cNvGrpSpPr/>
          <p:nvPr/>
        </p:nvGrpSpPr>
        <p:grpSpPr>
          <a:xfrm>
            <a:off x="4695503" y="1484784"/>
            <a:ext cx="4422526" cy="2531541"/>
            <a:chOff x="4695503" y="1556792"/>
            <a:chExt cx="4422526" cy="2531541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695503" y="1556792"/>
              <a:ext cx="4340993" cy="2522275"/>
            </a:xfrm>
            <a:prstGeom prst="rect">
              <a:avLst/>
            </a:prstGeom>
          </p:spPr>
        </p:pic>
        <p:sp>
          <p:nvSpPr>
            <p:cNvPr id="30" name="正方形/長方形 29"/>
            <p:cNvSpPr/>
            <p:nvPr/>
          </p:nvSpPr>
          <p:spPr>
            <a:xfrm>
              <a:off x="8582138" y="2223914"/>
              <a:ext cx="535891" cy="86409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3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2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1</a:t>
              </a:r>
              <a:endPara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0</a:t>
              </a:r>
            </a:p>
          </p:txBody>
        </p:sp>
        <p:sp>
          <p:nvSpPr>
            <p:cNvPr id="33" name="正方形/長方形 32"/>
            <p:cNvSpPr/>
            <p:nvPr/>
          </p:nvSpPr>
          <p:spPr>
            <a:xfrm>
              <a:off x="5724128" y="3789040"/>
              <a:ext cx="2664296" cy="2160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12M    15M   18M   21M    24M    27M   30M    33M   36M</a:t>
              </a:r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4984998" y="3769573"/>
              <a:ext cx="339452" cy="31876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During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5343500" y="3779097"/>
              <a:ext cx="351656" cy="29996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End of 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grpSp>
        <p:nvGrpSpPr>
          <p:cNvPr id="4" name="グループ化 41"/>
          <p:cNvGrpSpPr/>
          <p:nvPr/>
        </p:nvGrpSpPr>
        <p:grpSpPr>
          <a:xfrm>
            <a:off x="323528" y="1412776"/>
            <a:ext cx="4424323" cy="2639739"/>
            <a:chOff x="323528" y="1484784"/>
            <a:chExt cx="4424323" cy="2639739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23528" y="1484784"/>
              <a:ext cx="4320480" cy="2613074"/>
            </a:xfrm>
            <a:prstGeom prst="rect">
              <a:avLst/>
            </a:prstGeom>
          </p:spPr>
        </p:pic>
        <p:sp>
          <p:nvSpPr>
            <p:cNvPr id="25" name="正方形/長方形 24"/>
            <p:cNvSpPr/>
            <p:nvPr/>
          </p:nvSpPr>
          <p:spPr>
            <a:xfrm>
              <a:off x="4211960" y="2276872"/>
              <a:ext cx="535891" cy="86409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3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2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1</a:t>
              </a:r>
              <a:endPara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0</a:t>
              </a:r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1301278" y="3815705"/>
              <a:ext cx="2664296" cy="2160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12M    15M   18M   21M    24M    27M    30M    33M   36M</a:t>
              </a:r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562148" y="3805763"/>
              <a:ext cx="339452" cy="31876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During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38" name="正方形/長方形 37"/>
            <p:cNvSpPr/>
            <p:nvPr/>
          </p:nvSpPr>
          <p:spPr>
            <a:xfrm>
              <a:off x="920650" y="3815287"/>
              <a:ext cx="351656" cy="29996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End of 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grpSp>
        <p:nvGrpSpPr>
          <p:cNvPr id="5" name="グループ化 43"/>
          <p:cNvGrpSpPr/>
          <p:nvPr/>
        </p:nvGrpSpPr>
        <p:grpSpPr>
          <a:xfrm>
            <a:off x="395536" y="4398788"/>
            <a:ext cx="4229671" cy="2430290"/>
            <a:chOff x="395536" y="4398788"/>
            <a:chExt cx="4229671" cy="2430290"/>
          </a:xfrm>
        </p:grpSpPr>
        <p:pic>
          <p:nvPicPr>
            <p:cNvPr id="18" name="図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95536" y="4398788"/>
              <a:ext cx="4090988" cy="2414588"/>
            </a:xfrm>
            <a:prstGeom prst="rect">
              <a:avLst/>
            </a:prstGeom>
          </p:spPr>
        </p:pic>
        <p:sp>
          <p:nvSpPr>
            <p:cNvPr id="31" name="正方形/長方形 30"/>
            <p:cNvSpPr/>
            <p:nvPr/>
          </p:nvSpPr>
          <p:spPr>
            <a:xfrm>
              <a:off x="4089316" y="5013176"/>
              <a:ext cx="535891" cy="86409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3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2</a:t>
              </a: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1</a:t>
              </a:r>
              <a:endPara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  <a:p>
              <a:pPr algn="ctr">
                <a:lnSpc>
                  <a:spcPts val="16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Grade 0</a:t>
              </a:r>
            </a:p>
          </p:txBody>
        </p:sp>
        <p:sp>
          <p:nvSpPr>
            <p:cNvPr id="39" name="正方形/長方形 38"/>
            <p:cNvSpPr/>
            <p:nvPr/>
          </p:nvSpPr>
          <p:spPr>
            <a:xfrm>
              <a:off x="1289295" y="6510318"/>
              <a:ext cx="2664296" cy="2160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>
                <a:lnSpc>
                  <a:spcPts val="12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12M   15M   18M   21M    24M    27M   30M   33M   36M</a:t>
              </a:r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562115" y="6510318"/>
              <a:ext cx="339452" cy="31876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During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  <p:sp>
          <p:nvSpPr>
            <p:cNvPr id="41" name="正方形/長方形 40"/>
            <p:cNvSpPr/>
            <p:nvPr/>
          </p:nvSpPr>
          <p:spPr>
            <a:xfrm>
              <a:off x="920650" y="6519713"/>
              <a:ext cx="351656" cy="29996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>
              <a:no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altLang="ja-JP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End of  </a:t>
              </a:r>
              <a:r>
                <a:rPr lang="en-US" altLang="ja-JP" sz="9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trt</a:t>
              </a:r>
              <a:endParaRPr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sp>
        <p:nvSpPr>
          <p:cNvPr id="19" name="正方形/長方形 18"/>
          <p:cNvSpPr/>
          <p:nvPr/>
        </p:nvSpPr>
        <p:spPr>
          <a:xfrm>
            <a:off x="971600" y="447055"/>
            <a:ext cx="772602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b="1" dirty="0">
                <a:latin typeface="Times New Roman" pitchFamily="18" charset="0"/>
                <a:cs typeface="Times New Roman" pitchFamily="18" charset="0"/>
              </a:rPr>
              <a:t>Recovery from each Grade PSN during follow-up periods</a:t>
            </a:r>
            <a:endParaRPr lang="ja-JP" altLang="en-US" sz="24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940152" y="1196752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Grad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47664" y="1196752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Grad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0" y="21999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07504" y="1043444"/>
            <a:ext cx="909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460030" y="1043444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547664" y="4067780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Grad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07504" y="4050104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39199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2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00239</dc:creator>
  <cp:lastModifiedBy>0000239</cp:lastModifiedBy>
  <cp:revision>1</cp:revision>
  <dcterms:created xsi:type="dcterms:W3CDTF">2019-09-06T13:28:04Z</dcterms:created>
  <dcterms:modified xsi:type="dcterms:W3CDTF">2019-09-06T13:32:31Z</dcterms:modified>
</cp:coreProperties>
</file>